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75"/>
    <p:restoredTop sz="95735"/>
  </p:normalViewPr>
  <p:slideViewPr>
    <p:cSldViewPr snapToGrid="0">
      <p:cViewPr varScale="1">
        <p:scale>
          <a:sx n="147" d="100"/>
          <a:sy n="147" d="100"/>
        </p:scale>
        <p:origin x="24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8963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5571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9426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5241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9133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0038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2354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4216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2589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821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9840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219D5-A5A4-5E47-B641-D52BAB05A78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F4627-2B09-F849-8A9D-030D9440157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2071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BE539315-E1B7-2539-6D42-8BC10EB64A0B}"/>
              </a:ext>
            </a:extLst>
          </p:cNvPr>
          <p:cNvSpPr txBox="1"/>
          <p:nvPr/>
        </p:nvSpPr>
        <p:spPr>
          <a:xfrm>
            <a:off x="138456" y="7613022"/>
            <a:ext cx="658108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Construction and analysis of the </a:t>
            </a:r>
            <a:r>
              <a:rPr lang="en-GB" sz="12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B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and their derivative reporter strains propagating the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ids </a:t>
            </a:r>
          </a:p>
          <a:p>
            <a:r>
              <a:rPr lang="en-GB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ll genes are represented by colored arrows pointing into the direction of their transcription.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construction of the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phaAB_Km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rboring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GB" sz="1200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cassette.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 and Down stand for the region of homology with the beginning of the protein coding sequence (CS) of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he end of the CS of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These Up and Down platforms are used by DNA recombination promoting the replacement of most of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S by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during transformation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wis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UC4K are commercial plasmids (Table S2).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ypical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UV-light images of the agarose gels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relevant PCR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duct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clones of the </a:t>
            </a:r>
            <a:r>
              <a:rPr lang="el-G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fr-FR" sz="1200" i="1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haAB</a:t>
            </a:r>
            <a:r>
              <a:rPr lang="fr-FR" sz="1200" i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fr-FR" sz="1200" baseline="300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i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ain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rboring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or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Note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se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reporter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ain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osses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fr-FR" sz="1200" i="1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haAB</a:t>
            </a:r>
            <a:r>
              <a:rPr lang="fr-FR" sz="1200" i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fr-FR" sz="1200" baseline="300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baseline="30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pies of the chromosome copies (no WT copies). Size marker 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= 1 kb Plus DNA Ladder.</a:t>
            </a:r>
            <a:endParaRPr lang="fr-FR" sz="1200" dirty="0">
              <a:solidFill>
                <a:srgbClr val="FF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30C356A9-C547-DFA5-8694-6E04C35FCD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6980" y="59872"/>
            <a:ext cx="4210806" cy="3529787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3F39E5BF-28D1-5326-9A16-984CC2A3C6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4156" y="3720119"/>
            <a:ext cx="5169947" cy="37257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77155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8</TotalTime>
  <Words>201</Words>
  <Application>Microsoft Macintosh PowerPoint</Application>
  <PresentationFormat>Format A4 (210 x 297 mm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ck Chauvat</dc:creator>
  <cp:lastModifiedBy>Franck Chauvat</cp:lastModifiedBy>
  <cp:revision>25</cp:revision>
  <dcterms:created xsi:type="dcterms:W3CDTF">2023-08-11T21:20:46Z</dcterms:created>
  <dcterms:modified xsi:type="dcterms:W3CDTF">2023-11-13T15:56:00Z</dcterms:modified>
</cp:coreProperties>
</file>